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10058400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6357" autoAdjust="0"/>
  </p:normalViewPr>
  <p:slideViewPr>
    <p:cSldViewPr snapToObjects="1">
      <p:cViewPr varScale="1">
        <p:scale>
          <a:sx n="73" d="100"/>
          <a:sy n="73" d="100"/>
        </p:scale>
        <p:origin x="3840" y="30"/>
      </p:cViewPr>
      <p:guideLst>
        <p:guide orient="horz" pos="316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image" Target="../media/image1.png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>
            <a:extLst>
              <a:ext uri="{FF2B5EF4-FFF2-40B4-BE49-F238E27FC236}">
                <a16:creationId xmlns:a16="http://schemas.microsoft.com/office/drawing/2014/main" id="{1B9194C3-0813-46F3-A5B0-A3D7EB705695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defTabSz="465138" eaLnBrk="0" hangingPunct="0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9459" name="Rectangle 3">
            <a:extLst>
              <a:ext uri="{FF2B5EF4-FFF2-40B4-BE49-F238E27FC236}">
                <a16:creationId xmlns:a16="http://schemas.microsoft.com/office/drawing/2014/main" id="{1ABD3466-B8CE-4A69-B292-CF838E415200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 defTabSz="465138" eaLnBrk="0" hangingPunct="0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fld id="{964595A9-B698-4F0F-80A0-FD46597D02C4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19460" name="Rectangle 4">
            <a:extLst>
              <a:ext uri="{FF2B5EF4-FFF2-40B4-BE49-F238E27FC236}">
                <a16:creationId xmlns:a16="http://schemas.microsoft.com/office/drawing/2014/main" id="{FFE743B8-D530-4408-AA99-6F04F37D62D4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defTabSz="465138" eaLnBrk="0" hangingPunct="0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9461" name="Rectangle 5">
            <a:extLst>
              <a:ext uri="{FF2B5EF4-FFF2-40B4-BE49-F238E27FC236}">
                <a16:creationId xmlns:a16="http://schemas.microsoft.com/office/drawing/2014/main" id="{718699E8-61D7-4282-AAC0-85A5FC517DD5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defTabSz="465138" eaLnBrk="0" hangingPunct="0">
              <a:defRPr sz="1200"/>
            </a:lvl1pPr>
          </a:lstStyle>
          <a:p>
            <a:fld id="{76DA9C87-653E-4A52-9BA6-E4E4F5D8507E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10A3F92-8710-477E-AC36-785FA5F85F4C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04ACAE-BCC6-42E0-81AB-1AD13BDF3360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fld id="{5ECDFA2F-1D7B-49BC-837D-49C2669C2ABE}" type="datetimeFigureOut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B312A4CF-2779-4606-8B5D-F312063C619B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696913"/>
            <a:ext cx="23749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01287EE8-6AA2-4712-8850-357619EC24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D338BE-73E8-4185-A0F3-30E39B4C6ECE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FCC1CA-7072-4560-9DA7-65161F9AA46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ACBF3A5-0896-4FE8-BD26-CDE65562FF93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>
            <a:extLst>
              <a:ext uri="{FF2B5EF4-FFF2-40B4-BE49-F238E27FC236}">
                <a16:creationId xmlns:a16="http://schemas.microsoft.com/office/drawing/2014/main" id="{BBD67439-AFFF-4B96-9B6F-D26D6AE8E558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317750" y="696913"/>
            <a:ext cx="2374900" cy="348615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>
            <a:extLst>
              <a:ext uri="{FF2B5EF4-FFF2-40B4-BE49-F238E27FC236}">
                <a16:creationId xmlns:a16="http://schemas.microsoft.com/office/drawing/2014/main" id="{90D7C5BF-71D0-4E94-99FC-97464755405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/>
          </a:p>
        </p:txBody>
      </p:sp>
      <p:sp>
        <p:nvSpPr>
          <p:cNvPr id="5124" name="Slide Number Placeholder 3">
            <a:extLst>
              <a:ext uri="{FF2B5EF4-FFF2-40B4-BE49-F238E27FC236}">
                <a16:creationId xmlns:a16="http://schemas.microsoft.com/office/drawing/2014/main" id="{C25BFCE1-3FD7-4847-938E-3D408671EA2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fld id="{B8D2ADAB-A74C-4A4F-A5BA-024C6647F9CC}" type="slidenum">
              <a:rPr lang="en-US" altLang="en-US"/>
              <a:pPr eaLnBrk="1" hangingPunct="1"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124626"/>
            <a:ext cx="582930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99760"/>
            <a:ext cx="480060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4B86C7-71B3-4D7B-A166-9F6AACCF0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5A53C3-C961-4AA2-82D5-DBBCDCEE0902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CF2E5F-46E1-4894-A0DA-67CD55EAB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C51EB-8B1D-4835-B81B-C40B7366D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3717B3D-DCBB-4B28-A147-95DA6205CD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61743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FEA54-8447-4CF8-ADF7-49165223E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316CB3-03E6-45BD-BAEB-26711A5CE899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CBAC3A-2B30-4E37-85EB-F2C2067DE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E58713-69C4-4315-91AB-6737F5C41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5669ECE-83EA-4BC4-A506-1DDBAB219D1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58618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402805"/>
            <a:ext cx="1543050" cy="85822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402805"/>
            <a:ext cx="4514850" cy="85822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BE345-A971-47A2-93FE-04D454C52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8D9488-9CE0-4292-8817-1E1AB9B195DF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6D8026-00D9-4387-9AAF-2D46320A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BA5DB-42BC-4CBC-AD87-0D6F68C37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DDDEFD1-8DE3-4E60-AF59-1BE575DFA9E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76552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0A529-08FE-4BB2-8B06-354A366B6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21848B-111F-48AB-A022-8453286380A4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51B90F-FC1E-4298-9BE0-EF39FEB8E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30349-A734-48B7-A921-B9C4D3A23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4D263A-D786-4E51-AA14-93FF14E4E681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29763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463453"/>
            <a:ext cx="582930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263183"/>
            <a:ext cx="582930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8B98C4-809B-4DB2-8104-A7AF00C01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401EC-D7A6-40D4-8CF7-04059FF8FA58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F55123-BFDA-428A-88B8-68DC7AE8E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E76443-788A-4D4B-9F8C-737C33546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A433AF-0F1D-4E0B-BC23-1DF14F4A990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60781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46963"/>
            <a:ext cx="3028950" cy="663807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46963"/>
            <a:ext cx="3028950" cy="663807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9FDB5C7-2196-4C24-8269-2E122D710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0CB64B-41AE-48FD-A395-CD7CE98315AA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7854A3F-086B-4C3B-917F-D63894FE6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E29EC4D-225E-4678-BFD0-E7C5147BF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06BA5D7-DBAB-4947-8A82-8C8371628C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13028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251500"/>
            <a:ext cx="3030141" cy="9383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3189817"/>
            <a:ext cx="3030141" cy="579522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51500"/>
            <a:ext cx="3031331" cy="9383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89817"/>
            <a:ext cx="3031331" cy="579522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91A6FFC9-E4B9-441C-8C6F-5192F879A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833674-50AA-4C49-8EE2-3EB55CDF6F44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0D681E89-C4D4-4473-B130-2386F2629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273A6F1-F9AD-4EBA-BDF6-4ADF231E8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4DB0846-D2A6-44CF-B206-06A3253EAB1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4738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6FA22499-955E-4FF0-9857-BF46DBA2B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1798B-8141-484B-8330-B5D491920197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BDC2BDEB-AAB1-40B8-9269-0D0D3E63D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F8ECE35-27D0-4172-8040-B0B12DAA6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DB08A92-A245-46B8-B89C-1C6BBA55DD6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96951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279DB723-5201-498A-A74C-50B7A2C29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C0104E-1C58-41FA-8D64-980F0011BC94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7CE12FB8-1BB4-45B4-B148-B67BA7402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D6203D2C-EEE1-4D47-8140-2C14F5695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30F01C-863A-4855-9EE1-3A9868BB7E94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08469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400473"/>
            <a:ext cx="2256235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400477"/>
            <a:ext cx="3833813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104817"/>
            <a:ext cx="2256235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55DE3EF-77CE-4927-A23D-780FEBAB6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8ED776-9EF9-4776-A3E4-2594E69BFAE1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58F8B27-F7A2-4248-9218-B8999ACD8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156A412-FC7A-4621-BB89-72F620884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9921F30-E185-4664-9D05-47BC6582AD2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4987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7040882"/>
            <a:ext cx="411480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98737"/>
            <a:ext cx="4114800" cy="603504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872098"/>
            <a:ext cx="411480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B8A2BBA-F763-49EB-B5CD-228DC9666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761EB9-1D09-41E2-9AF2-1628AB5E2961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94A7F57-7C03-4504-BFE6-CBFA495CF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DF08913-26CF-4318-BE27-E4AD36CA3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E9CBB5C-7D49-47D1-A853-21E164F8C05C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59616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>
            <a:extLst>
              <a:ext uri="{FF2B5EF4-FFF2-40B4-BE49-F238E27FC236}">
                <a16:creationId xmlns:a16="http://schemas.microsoft.com/office/drawing/2014/main" id="{06D28FA9-948B-4087-95A2-900B0C3E132D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403385"/>
            <a:ext cx="6172200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>
            <a:extLst>
              <a:ext uri="{FF2B5EF4-FFF2-40B4-BE49-F238E27FC236}">
                <a16:creationId xmlns:a16="http://schemas.microsoft.com/office/drawing/2014/main" id="{AB4C1FB7-E8EA-469F-9384-D2185A2F88E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346960"/>
            <a:ext cx="6172200" cy="66374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FBDC2F-0A16-4434-8BAF-073772B50A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9323229"/>
            <a:ext cx="1600200" cy="53435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  <a:ea typeface="ＭＳ Ｐゴシック" charset="-128"/>
              </a:defRPr>
            </a:lvl1pPr>
          </a:lstStyle>
          <a:p>
            <a:pPr>
              <a:defRPr/>
            </a:pPr>
            <a:fld id="{0551A5F9-4C4C-4B54-B415-6341727EB040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11849-3154-4F29-B8AA-145A963F31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9323229"/>
            <a:ext cx="2171700" cy="53435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A482C6-73E7-4F2D-A111-8B92659162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9323229"/>
            <a:ext cx="1600200" cy="53435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D533C491-EEDD-4B0B-881F-16190E1AD0AC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.png"/><Relationship Id="rId18" Type="http://schemas.openxmlformats.org/officeDocument/2006/relationships/image" Target="../media/image16.jpeg"/><Relationship Id="rId26" Type="http://schemas.openxmlformats.org/officeDocument/2006/relationships/image" Target="../media/image7.png"/><Relationship Id="rId39" Type="http://schemas.openxmlformats.org/officeDocument/2006/relationships/image" Target="../media/image23.png"/><Relationship Id="rId21" Type="http://schemas.openxmlformats.org/officeDocument/2006/relationships/image" Target="../media/image19.jpeg"/><Relationship Id="rId34" Type="http://schemas.openxmlformats.org/officeDocument/2006/relationships/image" Target="../media/image11.png"/><Relationship Id="rId7" Type="http://schemas.openxmlformats.org/officeDocument/2006/relationships/image" Target="../media/image1.png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6.png"/><Relationship Id="rId25" Type="http://schemas.openxmlformats.org/officeDocument/2006/relationships/oleObject" Target="../embeddings/oleObject7.bin"/><Relationship Id="rId33" Type="http://schemas.openxmlformats.org/officeDocument/2006/relationships/oleObject" Target="../embeddings/oleObject11.bin"/><Relationship Id="rId38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6.bin"/><Relationship Id="rId20" Type="http://schemas.openxmlformats.org/officeDocument/2006/relationships/image" Target="../media/image18.png"/><Relationship Id="rId29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3.png"/><Relationship Id="rId24" Type="http://schemas.openxmlformats.org/officeDocument/2006/relationships/image" Target="../media/image22.png"/><Relationship Id="rId32" Type="http://schemas.openxmlformats.org/officeDocument/2006/relationships/image" Target="../media/image10.png"/><Relationship Id="rId37" Type="http://schemas.openxmlformats.org/officeDocument/2006/relationships/oleObject" Target="../embeddings/oleObject13.bin"/><Relationship Id="rId5" Type="http://schemas.openxmlformats.org/officeDocument/2006/relationships/image" Target="../media/image15.png"/><Relationship Id="rId15" Type="http://schemas.openxmlformats.org/officeDocument/2006/relationships/image" Target="../media/image5.png"/><Relationship Id="rId23" Type="http://schemas.openxmlformats.org/officeDocument/2006/relationships/image" Target="../media/image21.png"/><Relationship Id="rId28" Type="http://schemas.openxmlformats.org/officeDocument/2006/relationships/image" Target="../media/image8.png"/><Relationship Id="rId36" Type="http://schemas.openxmlformats.org/officeDocument/2006/relationships/image" Target="../media/image12.png"/><Relationship Id="rId10" Type="http://schemas.openxmlformats.org/officeDocument/2006/relationships/oleObject" Target="../embeddings/oleObject3.bin"/><Relationship Id="rId19" Type="http://schemas.openxmlformats.org/officeDocument/2006/relationships/image" Target="../media/image17.png"/><Relationship Id="rId31" Type="http://schemas.openxmlformats.org/officeDocument/2006/relationships/oleObject" Target="../embeddings/oleObject10.bin"/><Relationship Id="rId4" Type="http://schemas.openxmlformats.org/officeDocument/2006/relationships/image" Target="../media/image14.png"/><Relationship Id="rId9" Type="http://schemas.openxmlformats.org/officeDocument/2006/relationships/image" Target="../media/image2.png"/><Relationship Id="rId14" Type="http://schemas.openxmlformats.org/officeDocument/2006/relationships/oleObject" Target="../embeddings/oleObject5.bin"/><Relationship Id="rId22" Type="http://schemas.openxmlformats.org/officeDocument/2006/relationships/image" Target="../media/image20.jpeg"/><Relationship Id="rId27" Type="http://schemas.openxmlformats.org/officeDocument/2006/relationships/oleObject" Target="../embeddings/oleObject8.bin"/><Relationship Id="rId30" Type="http://schemas.openxmlformats.org/officeDocument/2006/relationships/image" Target="../media/image9.png"/><Relationship Id="rId35" Type="http://schemas.openxmlformats.org/officeDocument/2006/relationships/oleObject" Target="../embeddings/oleObject12.bin"/><Relationship Id="rId8" Type="http://schemas.openxmlformats.org/officeDocument/2006/relationships/oleObject" Target="../embeddings/oleObject2.bin"/><Relationship Id="rId3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3" name="Content Placeholder 4">
            <a:extLst>
              <a:ext uri="{FF2B5EF4-FFF2-40B4-BE49-F238E27FC236}">
                <a16:creationId xmlns:a16="http://schemas.microsoft.com/office/drawing/2014/main" id="{A029CF20-16CB-4DA5-9328-72878284FD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1376" y="497961"/>
            <a:ext cx="1220688" cy="4691140"/>
          </a:xfrm>
        </p:spPr>
        <p:txBody>
          <a:bodyPr/>
          <a:lstStyle/>
          <a:p>
            <a:pPr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_FAJI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_D83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17b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2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4b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18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19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20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TIL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ppUrbB</a:t>
            </a:r>
            <a:endParaRPr lang="en-US" altLang="en-US" sz="17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AND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S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TOU-ALI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7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GUY-TER</a:t>
            </a:r>
            <a:endParaRPr lang="en-US" altLang="en-US" sz="24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1034" name="Picture 9">
            <a:extLst>
              <a:ext uri="{FF2B5EF4-FFF2-40B4-BE49-F238E27FC236}">
                <a16:creationId xmlns:a16="http://schemas.microsoft.com/office/drawing/2014/main" id="{A77DB952-2CA0-46C5-B27A-A6790CD3BDC1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369" y="497962"/>
            <a:ext cx="5639177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0">
            <a:extLst>
              <a:ext uri="{FF2B5EF4-FFF2-40B4-BE49-F238E27FC236}">
                <a16:creationId xmlns:a16="http://schemas.microsoft.com/office/drawing/2014/main" id="{D25AE413-A5E9-4B23-87EC-27D7444C4FDD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369" y="818638"/>
            <a:ext cx="5639176" cy="309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026" name="Object 10">
            <a:extLst>
              <a:ext uri="{FF2B5EF4-FFF2-40B4-BE49-F238E27FC236}">
                <a16:creationId xmlns:a16="http://schemas.microsoft.com/office/drawing/2014/main" id="{F45A4B81-41CE-4981-A9B5-4083294F67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6777101"/>
              </p:ext>
            </p:extLst>
          </p:nvPr>
        </p:nvGraphicFramePr>
        <p:xfrm>
          <a:off x="1150613" y="1427551"/>
          <a:ext cx="5631932" cy="3085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" name="Photo Editor Photo" r:id="rId6" imgW="2800741" imgH="133192" progId="MSPhotoEd.3">
                  <p:embed/>
                </p:oleObj>
              </mc:Choice>
              <mc:Fallback>
                <p:oleObj name="Photo Editor Photo" r:id="rId6" imgW="2800741" imgH="133192" progId="MSPhotoEd.3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0613" y="1427551"/>
                        <a:ext cx="5631932" cy="30857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7" name="Object 12">
            <a:extLst>
              <a:ext uri="{FF2B5EF4-FFF2-40B4-BE49-F238E27FC236}">
                <a16:creationId xmlns:a16="http://schemas.microsoft.com/office/drawing/2014/main" id="{DB457C84-9C91-4417-8484-5E1F8410A7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6507361"/>
              </p:ext>
            </p:extLst>
          </p:nvPr>
        </p:nvGraphicFramePr>
        <p:xfrm>
          <a:off x="1143369" y="1725060"/>
          <a:ext cx="5639176" cy="2991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" name="Photo Editor Photo" r:id="rId8" imgW="2752381" imgH="152260" progId="MSPhotoEd.3">
                  <p:embed/>
                </p:oleObj>
              </mc:Choice>
              <mc:Fallback>
                <p:oleObj name="Photo Editor Photo" r:id="rId8" imgW="2752381" imgH="152260" progId="MSPhotoEd.3">
                  <p:embed/>
                  <p:pic>
                    <p:nvPicPr>
                      <p:cNvPr id="0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3369" y="1725060"/>
                        <a:ext cx="5639176" cy="29915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8" name="Object 17">
            <a:extLst>
              <a:ext uri="{FF2B5EF4-FFF2-40B4-BE49-F238E27FC236}">
                <a16:creationId xmlns:a16="http://schemas.microsoft.com/office/drawing/2014/main" id="{3C051A98-2FB3-4A98-B211-C53254B862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9777283"/>
              </p:ext>
            </p:extLst>
          </p:nvPr>
        </p:nvGraphicFramePr>
        <p:xfrm>
          <a:off x="1157215" y="2743556"/>
          <a:ext cx="5625332" cy="31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" name="Photo Editor Photo" r:id="rId10" imgW="2809524" imgH="152260" progId="MSPhotoEd.3">
                  <p:embed/>
                </p:oleObj>
              </mc:Choice>
              <mc:Fallback>
                <p:oleObj name="Photo Editor Photo" r:id="rId10" imgW="2809524" imgH="152260" progId="MSPhotoEd.3">
                  <p:embed/>
                  <p:pic>
                    <p:nvPicPr>
                      <p:cNvPr id="0" name="Object 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7215" y="2743556"/>
                        <a:ext cx="5625332" cy="311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9" name="Object 18">
            <a:extLst>
              <a:ext uri="{FF2B5EF4-FFF2-40B4-BE49-F238E27FC236}">
                <a16:creationId xmlns:a16="http://schemas.microsoft.com/office/drawing/2014/main" id="{EFC1E807-382C-4557-9366-A3CFFB0D63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544189"/>
              </p:ext>
            </p:extLst>
          </p:nvPr>
        </p:nvGraphicFramePr>
        <p:xfrm>
          <a:off x="1158235" y="3050965"/>
          <a:ext cx="5624313" cy="311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" name="Photo Editor Photo" r:id="rId12" imgW="2762636" imgH="152260" progId="MSPhotoEd.3">
                  <p:embed/>
                </p:oleObj>
              </mc:Choice>
              <mc:Fallback>
                <p:oleObj name="Photo Editor Photo" r:id="rId12" imgW="2762636" imgH="152260" progId="MSPhotoEd.3">
                  <p:embed/>
                  <p:pic>
                    <p:nvPicPr>
                      <p:cNvPr id="0" name="Object 1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8235" y="3050965"/>
                        <a:ext cx="5624313" cy="311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31" name="Object 22">
            <a:extLst>
              <a:ext uri="{FF2B5EF4-FFF2-40B4-BE49-F238E27FC236}">
                <a16:creationId xmlns:a16="http://schemas.microsoft.com/office/drawing/2014/main" id="{1ED845B1-731E-4250-A6B0-5CBCA58DAE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3805290"/>
              </p:ext>
            </p:extLst>
          </p:nvPr>
        </p:nvGraphicFramePr>
        <p:xfrm>
          <a:off x="1159241" y="3639890"/>
          <a:ext cx="5623304" cy="248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" name="Photo Editor Photo" r:id="rId14" imgW="2771429" imgH="123842" progId="MSPhotoEd.3">
                  <p:embed/>
                </p:oleObj>
              </mc:Choice>
              <mc:Fallback>
                <p:oleObj name="Photo Editor Photo" r:id="rId14" imgW="2771429" imgH="123842" progId="MSPhotoEd.3">
                  <p:embed/>
                  <p:pic>
                    <p:nvPicPr>
                      <p:cNvPr id="0" name="Object 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9241" y="3639890"/>
                        <a:ext cx="5623304" cy="2489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32" name="Object 24">
            <a:extLst>
              <a:ext uri="{FF2B5EF4-FFF2-40B4-BE49-F238E27FC236}">
                <a16:creationId xmlns:a16="http://schemas.microsoft.com/office/drawing/2014/main" id="{BA7D5797-91B3-4B21-BDE6-07C3D18B5B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2020267"/>
              </p:ext>
            </p:extLst>
          </p:nvPr>
        </p:nvGraphicFramePr>
        <p:xfrm>
          <a:off x="1165331" y="3883542"/>
          <a:ext cx="5617217" cy="290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" name="Photo Editor Photo" r:id="rId16" imgW="2771429" imgH="171338" progId="MSPhotoEd.3">
                  <p:embed/>
                </p:oleObj>
              </mc:Choice>
              <mc:Fallback>
                <p:oleObj name="Photo Editor Photo" r:id="rId16" imgW="2771429" imgH="171338" progId="MSPhotoEd.3">
                  <p:embed/>
                  <p:pic>
                    <p:nvPicPr>
                      <p:cNvPr id="0" name="Object 2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3883542"/>
                        <a:ext cx="5617217" cy="29005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36" name="Picture 18" descr="24-25-26_3min.jpg">
            <a:extLst>
              <a:ext uri="{FF2B5EF4-FFF2-40B4-BE49-F238E27FC236}">
                <a16:creationId xmlns:a16="http://schemas.microsoft.com/office/drawing/2014/main" id="{245D2E83-7F5E-4C91-BAE4-58DB39873E89}"/>
              </a:ext>
            </a:extLst>
          </p:cNvPr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6" t="59564" r="12015" b="36983"/>
          <a:stretch/>
        </p:blipFill>
        <p:spPr bwMode="auto">
          <a:xfrm>
            <a:off x="1161532" y="4180231"/>
            <a:ext cx="5621015" cy="3478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9" descr="24-25-26_3min.jpg">
            <a:extLst>
              <a:ext uri="{FF2B5EF4-FFF2-40B4-BE49-F238E27FC236}">
                <a16:creationId xmlns:a16="http://schemas.microsoft.com/office/drawing/2014/main" id="{C4E67D5E-52AD-4FD3-9468-9EDC37AC558A}"/>
              </a:ext>
            </a:extLst>
          </p:cNvPr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6" t="66952" r="12015" b="29588"/>
          <a:stretch/>
        </p:blipFill>
        <p:spPr bwMode="auto">
          <a:xfrm>
            <a:off x="1165331" y="4528343"/>
            <a:ext cx="5617215" cy="3294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8">
            <a:extLst>
              <a:ext uri="{FF2B5EF4-FFF2-40B4-BE49-F238E27FC236}">
                <a16:creationId xmlns:a16="http://schemas.microsoft.com/office/drawing/2014/main" id="{2C836C4D-A335-4B7C-97EC-657130F903EE}"/>
              </a:ext>
            </a:extLst>
          </p:cNvPr>
          <p:cNvPicPr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369" y="3328173"/>
            <a:ext cx="5639179" cy="3048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9">
            <a:extLst>
              <a:ext uri="{FF2B5EF4-FFF2-40B4-BE49-F238E27FC236}">
                <a16:creationId xmlns:a16="http://schemas.microsoft.com/office/drawing/2014/main" id="{0DA84467-4033-418D-B1DF-04B044997E80}"/>
              </a:ext>
            </a:extLst>
          </p:cNvPr>
          <p:cNvPicPr>
            <a:picLocks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2"/>
          <a:stretch/>
        </p:blipFill>
        <p:spPr bwMode="auto">
          <a:xfrm>
            <a:off x="1150612" y="2363986"/>
            <a:ext cx="5631934" cy="371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0" name="Picture 26" descr="2010-02-02_5min.jpg">
            <a:extLst>
              <a:ext uri="{FF2B5EF4-FFF2-40B4-BE49-F238E27FC236}">
                <a16:creationId xmlns:a16="http://schemas.microsoft.com/office/drawing/2014/main" id="{939D9536-BDEA-4565-8001-C81FF895DEF4}"/>
              </a:ext>
            </a:extLst>
          </p:cNvPr>
          <p:cNvPicPr>
            <a:picLocks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58" t="48328" r="13367" b="48434"/>
          <a:stretch>
            <a:fillRect/>
          </a:stretch>
        </p:blipFill>
        <p:spPr bwMode="auto">
          <a:xfrm>
            <a:off x="1149719" y="1113611"/>
            <a:ext cx="5632827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1" name="Picture 17" descr="1-2-3_121109_5min.jpg">
            <a:extLst>
              <a:ext uri="{FF2B5EF4-FFF2-40B4-BE49-F238E27FC236}">
                <a16:creationId xmlns:a16="http://schemas.microsoft.com/office/drawing/2014/main" id="{66303F89-DC3A-457A-A909-31D20ABF4F26}"/>
              </a:ext>
            </a:extLst>
          </p:cNvPr>
          <p:cNvPicPr>
            <a:picLocks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70" t="14594" r="17963" b="81470"/>
          <a:stretch>
            <a:fillRect/>
          </a:stretch>
        </p:blipFill>
        <p:spPr bwMode="auto">
          <a:xfrm>
            <a:off x="1151636" y="2020926"/>
            <a:ext cx="5630910" cy="334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Rectangle 4">
            <a:extLst>
              <a:ext uri="{FF2B5EF4-FFF2-40B4-BE49-F238E27FC236}">
                <a16:creationId xmlns:a16="http://schemas.microsoft.com/office/drawing/2014/main" id="{085B1532-7829-437B-854D-60192BFE76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6357" y="277207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0" name="Rectangle 26">
            <a:extLst>
              <a:ext uri="{FF2B5EF4-FFF2-40B4-BE49-F238E27FC236}">
                <a16:creationId xmlns:a16="http://schemas.microsoft.com/office/drawing/2014/main" id="{CE3DB2C0-CFA2-4935-BF77-653505FD5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71285" y="277207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1" name="Rectangle 27">
            <a:extLst>
              <a:ext uri="{FF2B5EF4-FFF2-40B4-BE49-F238E27FC236}">
                <a16:creationId xmlns:a16="http://schemas.microsoft.com/office/drawing/2014/main" id="{03DDCA6D-0C06-40B4-8BF7-AF8D9DC6A4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3222" y="277207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22" name="Rectangle 28">
            <a:extLst>
              <a:ext uri="{FF2B5EF4-FFF2-40B4-BE49-F238E27FC236}">
                <a16:creationId xmlns:a16="http://schemas.microsoft.com/office/drawing/2014/main" id="{2710ACC5-03CC-4B47-B77F-906F1EF47D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7729" y="277207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3" name="Rectangle 29">
            <a:extLst>
              <a:ext uri="{FF2B5EF4-FFF2-40B4-BE49-F238E27FC236}">
                <a16:creationId xmlns:a16="http://schemas.microsoft.com/office/drawing/2014/main" id="{F896871B-A0C6-4998-B585-A0348564B7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9484" y="277207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24" name="Rectangle 30">
            <a:extLst>
              <a:ext uri="{FF2B5EF4-FFF2-40B4-BE49-F238E27FC236}">
                <a16:creationId xmlns:a16="http://schemas.microsoft.com/office/drawing/2014/main" id="{AED125C7-AA06-400D-BDBA-DD84BA2E0E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65899" y="277207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25" name="Rectangle 31">
            <a:extLst>
              <a:ext uri="{FF2B5EF4-FFF2-40B4-BE49-F238E27FC236}">
                <a16:creationId xmlns:a16="http://schemas.microsoft.com/office/drawing/2014/main" id="{135899BD-A27C-439C-B4DF-03B129B3DC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2598" y="277207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26" name="Rectangle 32">
            <a:extLst>
              <a:ext uri="{FF2B5EF4-FFF2-40B4-BE49-F238E27FC236}">
                <a16:creationId xmlns:a16="http://schemas.microsoft.com/office/drawing/2014/main" id="{B0118B14-59B7-480D-A393-0B2BA0C534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336" y="277207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27" name="Rectangle 33">
            <a:extLst>
              <a:ext uri="{FF2B5EF4-FFF2-40B4-BE49-F238E27FC236}">
                <a16:creationId xmlns:a16="http://schemas.microsoft.com/office/drawing/2014/main" id="{92BC65FD-512F-4242-9A23-660F659E48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1018" y="277207"/>
            <a:ext cx="777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28" name="Rectangle 34">
            <a:extLst>
              <a:ext uri="{FF2B5EF4-FFF2-40B4-BE49-F238E27FC236}">
                <a16:creationId xmlns:a16="http://schemas.microsoft.com/office/drawing/2014/main" id="{3D92A3E6-F87E-4845-975E-9D61FAEAC6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09936" y="277207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29" name="Rectangle 35">
            <a:extLst>
              <a:ext uri="{FF2B5EF4-FFF2-40B4-BE49-F238E27FC236}">
                <a16:creationId xmlns:a16="http://schemas.microsoft.com/office/drawing/2014/main" id="{C93FD97C-FA6B-4EE3-8414-C3B4B96ECE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4569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30" name="Rectangle 36">
            <a:extLst>
              <a:ext uri="{FF2B5EF4-FFF2-40B4-BE49-F238E27FC236}">
                <a16:creationId xmlns:a16="http://schemas.microsoft.com/office/drawing/2014/main" id="{820A965F-A845-44B4-A660-211766CE63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6485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1" name="Rectangle 37">
            <a:extLst>
              <a:ext uri="{FF2B5EF4-FFF2-40B4-BE49-F238E27FC236}">
                <a16:creationId xmlns:a16="http://schemas.microsoft.com/office/drawing/2014/main" id="{5E3B27E6-0081-4E7D-9AA2-26877E55DA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1435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32" name="Rectangle 38">
            <a:extLst>
              <a:ext uri="{FF2B5EF4-FFF2-40B4-BE49-F238E27FC236}">
                <a16:creationId xmlns:a16="http://schemas.microsoft.com/office/drawing/2014/main" id="{72D2D8AB-A8AA-4416-ADF1-CF827AFE97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9889" y="277207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33" name="Rectangle 39">
            <a:extLst>
              <a:ext uri="{FF2B5EF4-FFF2-40B4-BE49-F238E27FC236}">
                <a16:creationId xmlns:a16="http://schemas.microsoft.com/office/drawing/2014/main" id="{27A5CAA9-EB9A-4E69-8B33-189894381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5979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34" name="Rectangle 40">
            <a:extLst>
              <a:ext uri="{FF2B5EF4-FFF2-40B4-BE49-F238E27FC236}">
                <a16:creationId xmlns:a16="http://schemas.microsoft.com/office/drawing/2014/main" id="{7B5A9EEF-51B6-474D-9425-FFF6A0D6AF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9669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35" name="Rectangle 41">
            <a:extLst>
              <a:ext uri="{FF2B5EF4-FFF2-40B4-BE49-F238E27FC236}">
                <a16:creationId xmlns:a16="http://schemas.microsoft.com/office/drawing/2014/main" id="{257D8A1B-F9FC-4BA0-A628-BB1CA74DE8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85235" y="277207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</p:txBody>
      </p:sp>
      <p:sp>
        <p:nvSpPr>
          <p:cNvPr id="36" name="Rectangle 42">
            <a:extLst>
              <a:ext uri="{FF2B5EF4-FFF2-40B4-BE49-F238E27FC236}">
                <a16:creationId xmlns:a16="http://schemas.microsoft.com/office/drawing/2014/main" id="{BF446C4B-BD06-445B-91A2-82D09D7D6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7328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37" name="Rectangle 43">
            <a:extLst>
              <a:ext uri="{FF2B5EF4-FFF2-40B4-BE49-F238E27FC236}">
                <a16:creationId xmlns:a16="http://schemas.microsoft.com/office/drawing/2014/main" id="{5E7CEA84-19F1-4AAB-954F-EF1318B1C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1629" y="277207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  <p:sp>
        <p:nvSpPr>
          <p:cNvPr id="38" name="Rectangle 44">
            <a:extLst>
              <a:ext uri="{FF2B5EF4-FFF2-40B4-BE49-F238E27FC236}">
                <a16:creationId xmlns:a16="http://schemas.microsoft.com/office/drawing/2014/main" id="{F660322A-179F-429A-A65E-D9B951935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4046" y="277207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1" name="Rectangle 4">
            <a:extLst>
              <a:ext uri="{FF2B5EF4-FFF2-40B4-BE49-F238E27FC236}">
                <a16:creationId xmlns:a16="http://schemas.microsoft.com/office/drawing/2014/main" id="{A3FBC97D-4E0A-4332-A445-6CAD1D7A59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7812" y="5332765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42" name="Rectangle 26">
            <a:extLst>
              <a:ext uri="{FF2B5EF4-FFF2-40B4-BE49-F238E27FC236}">
                <a16:creationId xmlns:a16="http://schemas.microsoft.com/office/drawing/2014/main" id="{A3ACAEBC-BA8F-4721-AFDA-B059174243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7722" y="5332765"/>
            <a:ext cx="1917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43" name="Rectangle 27">
            <a:extLst>
              <a:ext uri="{FF2B5EF4-FFF2-40B4-BE49-F238E27FC236}">
                <a16:creationId xmlns:a16="http://schemas.microsoft.com/office/drawing/2014/main" id="{09A21483-8AC7-4C0D-A7AF-D82F11FE6E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4733" y="5332765"/>
            <a:ext cx="1748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44" name="Rectangle 28">
            <a:extLst>
              <a:ext uri="{FF2B5EF4-FFF2-40B4-BE49-F238E27FC236}">
                <a16:creationId xmlns:a16="http://schemas.microsoft.com/office/drawing/2014/main" id="{9AEF06C4-63FA-4E5B-96DF-265D603841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9875" y="5331152"/>
            <a:ext cx="2180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45" name="Rectangle 29">
            <a:extLst>
              <a:ext uri="{FF2B5EF4-FFF2-40B4-BE49-F238E27FC236}">
                <a16:creationId xmlns:a16="http://schemas.microsoft.com/office/drawing/2014/main" id="{F93CDAFC-D8B5-46F1-A42C-02A4471034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3858" y="5332765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46" name="Rectangle 30">
            <a:extLst>
              <a:ext uri="{FF2B5EF4-FFF2-40B4-BE49-F238E27FC236}">
                <a16:creationId xmlns:a16="http://schemas.microsoft.com/office/drawing/2014/main" id="{2BA589C7-9966-403D-86C2-B2A0E522C3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9984" y="5329541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47" name="Rectangle 31">
            <a:extLst>
              <a:ext uri="{FF2B5EF4-FFF2-40B4-BE49-F238E27FC236}">
                <a16:creationId xmlns:a16="http://schemas.microsoft.com/office/drawing/2014/main" id="{1637F718-814D-4B3D-BDDB-47025FF2F9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4326" y="5332765"/>
            <a:ext cx="186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</a:p>
        </p:txBody>
      </p:sp>
      <p:sp>
        <p:nvSpPr>
          <p:cNvPr id="48" name="Rectangle 32">
            <a:extLst>
              <a:ext uri="{FF2B5EF4-FFF2-40B4-BE49-F238E27FC236}">
                <a16:creationId xmlns:a16="http://schemas.microsoft.com/office/drawing/2014/main" id="{5A43E142-E068-4B4F-8ADE-0D3DDECB0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4767" y="5332765"/>
            <a:ext cx="20502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49" name="Rectangle 33">
            <a:extLst>
              <a:ext uri="{FF2B5EF4-FFF2-40B4-BE49-F238E27FC236}">
                <a16:creationId xmlns:a16="http://schemas.microsoft.com/office/drawing/2014/main" id="{53817EDF-5187-465C-AC94-ED464D99EA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8071" y="5332765"/>
            <a:ext cx="18367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  <p:sp>
        <p:nvSpPr>
          <p:cNvPr id="50" name="Rectangle 34">
            <a:extLst>
              <a:ext uri="{FF2B5EF4-FFF2-40B4-BE49-F238E27FC236}">
                <a16:creationId xmlns:a16="http://schemas.microsoft.com/office/drawing/2014/main" id="{DA0A1787-F0B1-42F5-A284-CF2D5855E0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6984" y="5332764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51" name="Rectangle 35">
            <a:extLst>
              <a:ext uri="{FF2B5EF4-FFF2-40B4-BE49-F238E27FC236}">
                <a16:creationId xmlns:a16="http://schemas.microsoft.com/office/drawing/2014/main" id="{C8B9BC30-54B1-438D-B1E2-AE21DF4904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1621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</a:p>
        </p:txBody>
      </p:sp>
      <p:sp>
        <p:nvSpPr>
          <p:cNvPr id="52" name="Rectangle 36">
            <a:extLst>
              <a:ext uri="{FF2B5EF4-FFF2-40B4-BE49-F238E27FC236}">
                <a16:creationId xmlns:a16="http://schemas.microsoft.com/office/drawing/2014/main" id="{230A8D12-E906-4D24-A2F6-36AA3332B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3538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  <p:sp>
        <p:nvSpPr>
          <p:cNvPr id="53" name="Rectangle 37">
            <a:extLst>
              <a:ext uri="{FF2B5EF4-FFF2-40B4-BE49-F238E27FC236}">
                <a16:creationId xmlns:a16="http://schemas.microsoft.com/office/drawing/2014/main" id="{794B4EAD-1FC7-426E-A2AB-1F40316D23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8487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</a:p>
        </p:txBody>
      </p:sp>
      <p:sp>
        <p:nvSpPr>
          <p:cNvPr id="54" name="Rectangle 38">
            <a:extLst>
              <a:ext uri="{FF2B5EF4-FFF2-40B4-BE49-F238E27FC236}">
                <a16:creationId xmlns:a16="http://schemas.microsoft.com/office/drawing/2014/main" id="{DE31E189-63DB-496C-9F50-251A16B8B1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6937" y="5332764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</p:txBody>
      </p:sp>
      <p:sp>
        <p:nvSpPr>
          <p:cNvPr id="55" name="Rectangle 39">
            <a:extLst>
              <a:ext uri="{FF2B5EF4-FFF2-40B4-BE49-F238E27FC236}">
                <a16:creationId xmlns:a16="http://schemas.microsoft.com/office/drawing/2014/main" id="{08486C0E-520E-4605-A1C0-E3B96AECBC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3033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56" name="Rectangle 40">
            <a:extLst>
              <a:ext uri="{FF2B5EF4-FFF2-40B4-BE49-F238E27FC236}">
                <a16:creationId xmlns:a16="http://schemas.microsoft.com/office/drawing/2014/main" id="{3864CD0F-C4AE-4BA9-91BD-AFABB5E735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6722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</a:p>
        </p:txBody>
      </p:sp>
      <p:sp>
        <p:nvSpPr>
          <p:cNvPr id="57" name="Rectangle 41">
            <a:extLst>
              <a:ext uri="{FF2B5EF4-FFF2-40B4-BE49-F238E27FC236}">
                <a16:creationId xmlns:a16="http://schemas.microsoft.com/office/drawing/2014/main" id="{78540F42-7DE6-4896-99FE-364BF10483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77813" y="5332764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58" name="Rectangle 42">
            <a:extLst>
              <a:ext uri="{FF2B5EF4-FFF2-40B4-BE49-F238E27FC236}">
                <a16:creationId xmlns:a16="http://schemas.microsoft.com/office/drawing/2014/main" id="{B04E98DA-64ED-4ADD-8F27-C55944A541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9912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</a:p>
        </p:txBody>
      </p:sp>
      <p:sp>
        <p:nvSpPr>
          <p:cNvPr id="59" name="Rectangle 43">
            <a:extLst>
              <a:ext uri="{FF2B5EF4-FFF2-40B4-BE49-F238E27FC236}">
                <a16:creationId xmlns:a16="http://schemas.microsoft.com/office/drawing/2014/main" id="{88479F1F-8222-4C1C-9C16-689731ECC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47698" y="5332764"/>
            <a:ext cx="31936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</a:p>
        </p:txBody>
      </p:sp>
      <p:sp>
        <p:nvSpPr>
          <p:cNvPr id="60" name="Rectangle 44">
            <a:extLst>
              <a:ext uri="{FF2B5EF4-FFF2-40B4-BE49-F238E27FC236}">
                <a16:creationId xmlns:a16="http://schemas.microsoft.com/office/drawing/2014/main" id="{CAB9E993-8BD7-49D1-97A7-31C9DC514E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0111" y="5332764"/>
            <a:ext cx="3193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pic>
        <p:nvPicPr>
          <p:cNvPr id="61" name="Picture 12">
            <a:extLst>
              <a:ext uri="{FF2B5EF4-FFF2-40B4-BE49-F238E27FC236}">
                <a16:creationId xmlns:a16="http://schemas.microsoft.com/office/drawing/2014/main" id="{E809DE1B-C1DA-4579-80DA-09C6EC54676E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5331" y="5543942"/>
            <a:ext cx="5629831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2" name="Picture 13">
            <a:extLst>
              <a:ext uri="{FF2B5EF4-FFF2-40B4-BE49-F238E27FC236}">
                <a16:creationId xmlns:a16="http://schemas.microsoft.com/office/drawing/2014/main" id="{88A04C57-C16F-424C-AF4F-6E22B18E3753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5331" y="5829361"/>
            <a:ext cx="5629831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63" name="Object 13">
            <a:extLst>
              <a:ext uri="{FF2B5EF4-FFF2-40B4-BE49-F238E27FC236}">
                <a16:creationId xmlns:a16="http://schemas.microsoft.com/office/drawing/2014/main" id="{52E74B36-567E-40F0-9077-C24197B1DA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037689"/>
              </p:ext>
            </p:extLst>
          </p:nvPr>
        </p:nvGraphicFramePr>
        <p:xfrm>
          <a:off x="1165331" y="6464690"/>
          <a:ext cx="5629831" cy="2741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6" name="Photo Editor Photo" r:id="rId25" imgW="2819794" imgH="142933" progId="MSPhotoEd.3">
                  <p:embed/>
                </p:oleObj>
              </mc:Choice>
              <mc:Fallback>
                <p:oleObj name="Photo Editor Photo" r:id="rId25" imgW="2819794" imgH="142933" progId="MSPhotoEd.3">
                  <p:embed/>
                  <p:pic>
                    <p:nvPicPr>
                      <p:cNvPr id="2050" name="Object 13">
                        <a:extLst>
                          <a:ext uri="{FF2B5EF4-FFF2-40B4-BE49-F238E27FC236}">
                            <a16:creationId xmlns:a16="http://schemas.microsoft.com/office/drawing/2014/main" id="{57CDD1E2-A705-4512-816E-2F13534EA09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6464690"/>
                        <a:ext cx="5629831" cy="27417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14">
            <a:extLst>
              <a:ext uri="{FF2B5EF4-FFF2-40B4-BE49-F238E27FC236}">
                <a16:creationId xmlns:a16="http://schemas.microsoft.com/office/drawing/2014/main" id="{B702A3EC-C6E6-4D6F-8B84-9BADE51E19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575392"/>
              </p:ext>
            </p:extLst>
          </p:nvPr>
        </p:nvGraphicFramePr>
        <p:xfrm>
          <a:off x="1165331" y="6738071"/>
          <a:ext cx="5629831" cy="2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" name="Photo Editor Photo" r:id="rId27" imgW="2781688" imgH="133192" progId="MSPhotoEd.3">
                  <p:embed/>
                </p:oleObj>
              </mc:Choice>
              <mc:Fallback>
                <p:oleObj name="Photo Editor Photo" r:id="rId27" imgW="2781688" imgH="133192" progId="MSPhotoEd.3">
                  <p:embed/>
                  <p:pic>
                    <p:nvPicPr>
                      <p:cNvPr id="2051" name="Object 14">
                        <a:extLst>
                          <a:ext uri="{FF2B5EF4-FFF2-40B4-BE49-F238E27FC236}">
                            <a16:creationId xmlns:a16="http://schemas.microsoft.com/office/drawing/2014/main" id="{060214A1-082A-4E48-B8C7-FD86FE3078D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6738071"/>
                        <a:ext cx="5629831" cy="2749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22">
            <a:extLst>
              <a:ext uri="{FF2B5EF4-FFF2-40B4-BE49-F238E27FC236}">
                <a16:creationId xmlns:a16="http://schemas.microsoft.com/office/drawing/2014/main" id="{764E9E50-C67D-4747-AB25-4F279112D8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6682009"/>
              </p:ext>
            </p:extLst>
          </p:nvPr>
        </p:nvGraphicFramePr>
        <p:xfrm>
          <a:off x="1165331" y="7670731"/>
          <a:ext cx="5629831" cy="27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8" name="Photo Editor Photo" r:id="rId29" imgW="2838846" imgH="142933" progId="MSPhotoEd.3">
                  <p:embed/>
                </p:oleObj>
              </mc:Choice>
              <mc:Fallback>
                <p:oleObj name="Photo Editor Photo" r:id="rId29" imgW="2838846" imgH="142933" progId="MSPhotoEd.3">
                  <p:embed/>
                  <p:pic>
                    <p:nvPicPr>
                      <p:cNvPr id="2052" name="Object 22">
                        <a:extLst>
                          <a:ext uri="{FF2B5EF4-FFF2-40B4-BE49-F238E27FC236}">
                            <a16:creationId xmlns:a16="http://schemas.microsoft.com/office/drawing/2014/main" id="{023B08CE-6A4A-4754-9C53-244D8EDD3A7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7670731"/>
                        <a:ext cx="5629831" cy="276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" name="Object 24">
            <a:extLst>
              <a:ext uri="{FF2B5EF4-FFF2-40B4-BE49-F238E27FC236}">
                <a16:creationId xmlns:a16="http://schemas.microsoft.com/office/drawing/2014/main" id="{F234F807-CBB8-4A94-9ED3-2AEB594718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5968241"/>
              </p:ext>
            </p:extLst>
          </p:nvPr>
        </p:nvGraphicFramePr>
        <p:xfrm>
          <a:off x="1165331" y="7951162"/>
          <a:ext cx="5629831" cy="28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" name="Photo Editor Photo" r:id="rId31" imgW="2771429" imgH="142933" progId="MSPhotoEd.3">
                  <p:embed/>
                </p:oleObj>
              </mc:Choice>
              <mc:Fallback>
                <p:oleObj name="Photo Editor Photo" r:id="rId31" imgW="2771429" imgH="142933" progId="MSPhotoEd.3">
                  <p:embed/>
                  <p:pic>
                    <p:nvPicPr>
                      <p:cNvPr id="2053" name="Object 24">
                        <a:extLst>
                          <a:ext uri="{FF2B5EF4-FFF2-40B4-BE49-F238E27FC236}">
                            <a16:creationId xmlns:a16="http://schemas.microsoft.com/office/drawing/2014/main" id="{5E57D815-1BE6-4A69-8BDC-BBB1237D7C7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7951162"/>
                        <a:ext cx="5629831" cy="288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" name="Object 26">
            <a:extLst>
              <a:ext uri="{FF2B5EF4-FFF2-40B4-BE49-F238E27FC236}">
                <a16:creationId xmlns:a16="http://schemas.microsoft.com/office/drawing/2014/main" id="{90481B47-FC9F-4159-A1B6-FF7E16FCAF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7254841"/>
              </p:ext>
            </p:extLst>
          </p:nvPr>
        </p:nvGraphicFramePr>
        <p:xfrm>
          <a:off x="1165331" y="8209464"/>
          <a:ext cx="5629831" cy="2724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0" name="Photo Editor Photo" r:id="rId33" imgW="2819794" imgH="142933" progId="MSPhotoEd.3">
                  <p:embed/>
                </p:oleObj>
              </mc:Choice>
              <mc:Fallback>
                <p:oleObj name="Photo Editor Photo" r:id="rId33" imgW="2819794" imgH="142933" progId="MSPhotoEd.3">
                  <p:embed/>
                  <p:pic>
                    <p:nvPicPr>
                      <p:cNvPr id="2055" name="Object 26">
                        <a:extLst>
                          <a:ext uri="{FF2B5EF4-FFF2-40B4-BE49-F238E27FC236}">
                            <a16:creationId xmlns:a16="http://schemas.microsoft.com/office/drawing/2014/main" id="{549DBA48-F95F-45DE-B829-D13B22B9D3D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5331" y="8209464"/>
                        <a:ext cx="5629831" cy="27245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9" name="Object 27">
            <a:extLst>
              <a:ext uri="{FF2B5EF4-FFF2-40B4-BE49-F238E27FC236}">
                <a16:creationId xmlns:a16="http://schemas.microsoft.com/office/drawing/2014/main" id="{916BB24B-3684-439E-96B5-8E0E2186CE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0343324"/>
              </p:ext>
            </p:extLst>
          </p:nvPr>
        </p:nvGraphicFramePr>
        <p:xfrm>
          <a:off x="1159085" y="8481389"/>
          <a:ext cx="5629831" cy="260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1" name="Photo Editor Photo" r:id="rId35" imgW="2752381" imgH="161990" progId="MSPhotoEd.3">
                  <p:embed/>
                </p:oleObj>
              </mc:Choice>
              <mc:Fallback>
                <p:oleObj name="Photo Editor Photo" r:id="rId35" imgW="2752381" imgH="161990" progId="MSPhotoEd.3">
                  <p:embed/>
                  <p:pic>
                    <p:nvPicPr>
                      <p:cNvPr id="2056" name="Object 27">
                        <a:extLst>
                          <a:ext uri="{FF2B5EF4-FFF2-40B4-BE49-F238E27FC236}">
                            <a16:creationId xmlns:a16="http://schemas.microsoft.com/office/drawing/2014/main" id="{F8C03273-5DF4-463C-BD64-E9BE395BBDD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9085" y="8481389"/>
                        <a:ext cx="5629831" cy="2603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0" name="Object 29">
            <a:extLst>
              <a:ext uri="{FF2B5EF4-FFF2-40B4-BE49-F238E27FC236}">
                <a16:creationId xmlns:a16="http://schemas.microsoft.com/office/drawing/2014/main" id="{D1F95043-D3F2-465B-AE6F-2E159E0BC4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1176108"/>
              </p:ext>
            </p:extLst>
          </p:nvPr>
        </p:nvGraphicFramePr>
        <p:xfrm>
          <a:off x="1167017" y="8724367"/>
          <a:ext cx="5621552" cy="324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2" name="Photo Editor Photo" r:id="rId37" imgW="2752381" imgH="190426" progId="MSPhotoEd.3">
                  <p:embed/>
                </p:oleObj>
              </mc:Choice>
              <mc:Fallback>
                <p:oleObj name="Photo Editor Photo" r:id="rId37" imgW="2752381" imgH="190426" progId="MSPhotoEd.3">
                  <p:embed/>
                  <p:pic>
                    <p:nvPicPr>
                      <p:cNvPr id="2057" name="Object 29">
                        <a:extLst>
                          <a:ext uri="{FF2B5EF4-FFF2-40B4-BE49-F238E27FC236}">
                            <a16:creationId xmlns:a16="http://schemas.microsoft.com/office/drawing/2014/main" id="{67A31863-9AD7-4905-821A-DF5CB17A1D1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7017" y="8724367"/>
                        <a:ext cx="5621552" cy="32433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1" name="Picture 17" descr="24-25-26_3min.jpg">
            <a:extLst>
              <a:ext uri="{FF2B5EF4-FFF2-40B4-BE49-F238E27FC236}">
                <a16:creationId xmlns:a16="http://schemas.microsoft.com/office/drawing/2014/main" id="{FB070CB0-40C4-43FE-ABA0-D198653768A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6" t="70206" r="12015" b="25961"/>
          <a:stretch>
            <a:fillRect/>
          </a:stretch>
        </p:blipFill>
        <p:spPr bwMode="auto">
          <a:xfrm>
            <a:off x="1158921" y="9371881"/>
            <a:ext cx="563624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" name="Picture 18" descr="24-25-26_3min.jpg">
            <a:extLst>
              <a:ext uri="{FF2B5EF4-FFF2-40B4-BE49-F238E27FC236}">
                <a16:creationId xmlns:a16="http://schemas.microsoft.com/office/drawing/2014/main" id="{54B0CDB6-DCB2-4FC3-A083-2E7906C83BBA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6" t="62844" r="12015" b="33946"/>
          <a:stretch/>
        </p:blipFill>
        <p:spPr bwMode="auto">
          <a:xfrm>
            <a:off x="1162468" y="9048919"/>
            <a:ext cx="5626374" cy="324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3" name="Picture 18">
            <a:extLst>
              <a:ext uri="{FF2B5EF4-FFF2-40B4-BE49-F238E27FC236}">
                <a16:creationId xmlns:a16="http://schemas.microsoft.com/office/drawing/2014/main" id="{6281FC2B-89CA-4F27-97E6-EE3F001DEBF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" r="120"/>
          <a:stretch/>
        </p:blipFill>
        <p:spPr bwMode="auto">
          <a:xfrm>
            <a:off x="1165503" y="7321480"/>
            <a:ext cx="5623067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4" name="Picture 21" descr="2010-02-02_5min.jpg">
            <a:extLst>
              <a:ext uri="{FF2B5EF4-FFF2-40B4-BE49-F238E27FC236}">
                <a16:creationId xmlns:a16="http://schemas.microsoft.com/office/drawing/2014/main" id="{459BF757-3E9C-430D-A1AF-BAF9BCBDA6C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58" t="51173" r="13367" b="45296"/>
          <a:stretch>
            <a:fillRect/>
          </a:stretch>
        </p:blipFill>
        <p:spPr bwMode="auto">
          <a:xfrm>
            <a:off x="1165331" y="6121790"/>
            <a:ext cx="5629831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5" name="Picture 19" descr="1-2-3_121109_5min.jpg">
            <a:extLst>
              <a:ext uri="{FF2B5EF4-FFF2-40B4-BE49-F238E27FC236}">
                <a16:creationId xmlns:a16="http://schemas.microsoft.com/office/drawing/2014/main" id="{BB30E2E2-E5E9-445E-98DC-BE39FD0CFA15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70" t="18439" r="17963" b="78066"/>
          <a:stretch/>
        </p:blipFill>
        <p:spPr bwMode="auto">
          <a:xfrm>
            <a:off x="1165503" y="7020657"/>
            <a:ext cx="5623067" cy="297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7" name="Content Placeholder 4">
            <a:extLst>
              <a:ext uri="{FF2B5EF4-FFF2-40B4-BE49-F238E27FC236}">
                <a16:creationId xmlns:a16="http://schemas.microsoft.com/office/drawing/2014/main" id="{F8FA7A00-4036-461E-B494-96C1CC2425C6}"/>
              </a:ext>
            </a:extLst>
          </p:cNvPr>
          <p:cNvSpPr txBox="1">
            <a:spLocks/>
          </p:cNvSpPr>
          <p:nvPr/>
        </p:nvSpPr>
        <p:spPr bwMode="auto">
          <a:xfrm>
            <a:off x="16988" y="5483026"/>
            <a:ext cx="1126381" cy="4691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None/>
            </a:pPr>
            <a:r>
              <a:rPr lang="en-US" altLang="en-US" sz="16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_FAJI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_D83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17b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2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_Fr4b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18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19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Fr20a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II_TIL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IppUrbB</a:t>
            </a:r>
            <a:endParaRPr lang="en-US" altLang="en-US" sz="165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AND</a:t>
            </a:r>
          </a:p>
          <a:p>
            <a:pPr>
              <a:buFont typeface="Arial" panose="020B0604020202020204" pitchFamily="34" charset="0"/>
              <a:buNone/>
            </a:pPr>
            <a:r>
              <a:rPr lang="en-US" altLang="en-US" sz="165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S</a:t>
            </a:r>
          </a:p>
          <a:p>
            <a:pPr>
              <a:buNone/>
            </a:pPr>
            <a:r>
              <a:rPr lang="en-US" altLang="en-US" sz="16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TOU-ALI</a:t>
            </a:r>
          </a:p>
          <a:p>
            <a:pPr>
              <a:buNone/>
            </a:pPr>
            <a:r>
              <a:rPr lang="en-US" altLang="en-US" sz="16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GUY-TER</a:t>
            </a:r>
            <a:endParaRPr lang="en-US" altLang="en-US" sz="20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5</TotalTime>
  <Words>105</Words>
  <Application>Microsoft Office PowerPoint</Application>
  <PresentationFormat>Custom</PresentationFormat>
  <Paragraphs>6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hoto Editor Photo</vt:lpstr>
      <vt:lpstr>PowerPoint Presentation</vt:lpstr>
    </vt:vector>
  </TitlesOfParts>
  <Company>MEEI/Harv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ynthia Cordeiro</dc:creator>
  <cp:lastModifiedBy>David Arranz Solís</cp:lastModifiedBy>
  <cp:revision>31</cp:revision>
  <cp:lastPrinted>2009-07-06T20:46:00Z</cp:lastPrinted>
  <dcterms:created xsi:type="dcterms:W3CDTF">2010-02-11T13:56:06Z</dcterms:created>
  <dcterms:modified xsi:type="dcterms:W3CDTF">2019-11-20T18:51:02Z</dcterms:modified>
</cp:coreProperties>
</file>